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9" r:id="rId3"/>
    <p:sldId id="257" r:id="rId4"/>
    <p:sldId id="258" r:id="rId5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113" d="100"/>
          <a:sy n="113" d="100"/>
        </p:scale>
        <p:origin x="474" y="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DD0D75B2-3333-4E37-9910-AE9095673BC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13DC1E4E-E39D-4933-9C0E-F18F0AAC8FAF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EBE6A125-7C9F-4DD7-BAB2-7E1F09B476E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154AB4-89D1-48F5-A222-3492C1A5F214}" type="datetimeFigureOut">
              <a:rPr lang="zh-CN" altLang="en-US" smtClean="0"/>
              <a:t>2020/4/24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58457F3F-EA8C-4C3C-B6D6-33190DF668C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70205120-4816-495F-80E0-7BC5781A6F2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D5436E-22E5-42D8-A8BC-4B0A6FFB762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9671857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931C6DB1-3B47-417D-9A1C-4E2147928EE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F996F3CC-5C24-4D6B-B1D3-4090B0B88AF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5C34AFC9-7D6E-4268-A4B2-C84B8F9FEB3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154AB4-89D1-48F5-A222-3492C1A5F214}" type="datetimeFigureOut">
              <a:rPr lang="zh-CN" altLang="en-US" smtClean="0"/>
              <a:t>2020/4/24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03E9A0DE-C74B-4D97-B8C9-581B15A4B2F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8DDE080F-CD17-45E1-87BA-71D981A11CC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D5436E-22E5-42D8-A8BC-4B0A6FFB762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6977065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6EEEBA4A-AEE0-4567-86A3-A3AD5E46FF04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57D13A00-D8B6-40AB-8FB2-6B7E7C36F7A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5FFE27FD-1E29-4874-BD72-32D6E7888D0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154AB4-89D1-48F5-A222-3492C1A5F214}" type="datetimeFigureOut">
              <a:rPr lang="zh-CN" altLang="en-US" smtClean="0"/>
              <a:t>2020/4/24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8E6C807C-FF64-49F8-97CF-30BD6392519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FABE8F29-9DF8-4435-B65F-DC85BADF467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D5436E-22E5-42D8-A8BC-4B0A6FFB762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084916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FBEA57F9-C398-43AF-AF5D-A1BBA3E5509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C7F311A3-1BDD-409F-A1DF-BBF26A725BD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0D03A903-6CB1-44C8-AD07-44594855BD8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154AB4-89D1-48F5-A222-3492C1A5F214}" type="datetimeFigureOut">
              <a:rPr lang="zh-CN" altLang="en-US" smtClean="0"/>
              <a:t>2020/4/24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3BF0729E-E30B-48B3-A5A3-284C4DFADCC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456B3A5A-B5F5-46AC-AE33-C4B5A4E279C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D5436E-22E5-42D8-A8BC-4B0A6FFB762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2350936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595A4125-721B-441F-8593-C4597B24DB0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E1A5DEEE-E561-427E-84AD-DFEA169757E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2437A715-08BE-4C94-971F-9CE4F9CAF81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154AB4-89D1-48F5-A222-3492C1A5F214}" type="datetimeFigureOut">
              <a:rPr lang="zh-CN" altLang="en-US" smtClean="0"/>
              <a:t>2020/4/24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27C63781-A9B2-4867-8E4F-79C3FA3DB28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D76119F3-3C48-4925-AE03-F74D6A82794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D5436E-22E5-42D8-A8BC-4B0A6FFB762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2529028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DE05F190-97A1-4864-BD1B-20863851115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745765F2-DBDA-4812-A216-00139DECA5AE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A1170E79-1AB8-48CC-BBD3-E59D66810F0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1B889D2E-B056-4DA3-A9BE-2F68D4399F5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154AB4-89D1-48F5-A222-3492C1A5F214}" type="datetimeFigureOut">
              <a:rPr lang="zh-CN" altLang="en-US" smtClean="0"/>
              <a:t>2020/4/24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03C9ED20-3850-4FE2-AA77-59F054BF843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6B919804-B999-47B6-90B0-5AFCC65E429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D5436E-22E5-42D8-A8BC-4B0A6FFB762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7754873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ADA1351D-BE05-4EE2-85DD-60D6281715C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A92DBC0E-5D26-4E27-9C33-2310844FB31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429E290E-8F1A-4BE3-AC7D-CEFC17A9ECA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4B3E3385-068C-48A8-8209-51EAF454864F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63DB8272-64A3-4E8F-9086-FCA60D6CED4B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AFE2152E-E394-4FD4-9C45-9F6124128C3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154AB4-89D1-48F5-A222-3492C1A5F214}" type="datetimeFigureOut">
              <a:rPr lang="zh-CN" altLang="en-US" smtClean="0"/>
              <a:t>2020/4/24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E234DA4C-D607-426F-9F4A-0613C6C98DF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8A4E8ABA-59D3-4420-BE28-C5CBE3CE4CE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D5436E-22E5-42D8-A8BC-4B0A6FFB762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0968255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C56A3B42-1759-44FD-A9A0-7193A4E244C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F367053B-293D-4C37-BCC0-2AFC4356DD4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154AB4-89D1-48F5-A222-3492C1A5F214}" type="datetimeFigureOut">
              <a:rPr lang="zh-CN" altLang="en-US" smtClean="0"/>
              <a:t>2020/4/24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7D6FFAD4-B75F-4822-90D8-81E955A04B4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FF58C6CE-DA16-4292-90B7-C3DB25EBD9F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D5436E-22E5-42D8-A8BC-4B0A6FFB762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7111378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2B629E59-F353-46B5-9DBF-15A83D5C79A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154AB4-89D1-48F5-A222-3492C1A5F214}" type="datetimeFigureOut">
              <a:rPr lang="zh-CN" altLang="en-US" smtClean="0"/>
              <a:t>2020/4/24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08C6E541-1A01-4722-91C1-6AD76606EAF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1292ED76-325B-4695-8665-192A1313582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D5436E-22E5-42D8-A8BC-4B0A6FFB762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0979676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ED956AD8-1043-4864-BE00-8934D7ACE34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D7D0E598-6F96-42FE-93D2-FDF1F89A6E8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6D6B64CD-C0A9-4046-97AD-BC86EFDA747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A2C3A131-E3B5-4C5B-9FF2-5E22C3315AB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154AB4-89D1-48F5-A222-3492C1A5F214}" type="datetimeFigureOut">
              <a:rPr lang="zh-CN" altLang="en-US" smtClean="0"/>
              <a:t>2020/4/24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84615565-23C9-4659-B217-60A39E042AA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BD122B25-50C7-45E1-AE1B-DCEF6E63F2B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D5436E-22E5-42D8-A8BC-4B0A6FFB762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8364170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6ED365E4-8ACC-4B65-84A8-98785859C27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A094A5D3-433C-4D78-8ABA-9D1D15EB9915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E3E71270-9397-4401-B57F-5F8BDD80056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0DC8F768-1C64-4753-82ED-6572EA64E3F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154AB4-89D1-48F5-A222-3492C1A5F214}" type="datetimeFigureOut">
              <a:rPr lang="zh-CN" altLang="en-US" smtClean="0"/>
              <a:t>2020/4/24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6F37E070-684D-4825-B6C2-CA29EA72CAA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4813AE4B-B2E9-48AE-B1B3-3D798FB3C2C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D5436E-22E5-42D8-A8BC-4B0A6FFB762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3311565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7BC75FF9-1BE6-4058-A192-A523709AEDC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CB5D3984-805A-4BF6-BC90-E296423F42B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22C21CB6-244B-4C14-AC8B-5C55E4F1954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E154AB4-89D1-48F5-A222-3492C1A5F214}" type="datetimeFigureOut">
              <a:rPr lang="zh-CN" altLang="en-US" smtClean="0"/>
              <a:t>2020/4/24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210AFB70-827C-43F7-9143-D9E994CB7D0D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E950F213-AEA5-4585-8E2E-A3A6BB76EAC3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3D5436E-22E5-42D8-A8BC-4B0A6FFB762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1126828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jp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jpe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>
            <a:extLst>
              <a:ext uri="{FF2B5EF4-FFF2-40B4-BE49-F238E27FC236}">
                <a16:creationId xmlns:a16="http://schemas.microsoft.com/office/drawing/2014/main" id="{345AC660-1EA6-4869-B648-5A682B9942BF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99037" y="73046"/>
            <a:ext cx="6223141" cy="6480000"/>
          </a:xfrm>
          <a:prstGeom prst="rect">
            <a:avLst/>
          </a:prstGeom>
        </p:spPr>
      </p:pic>
      <p:sp>
        <p:nvSpPr>
          <p:cNvPr id="7" name="文本框 6">
            <a:extLst>
              <a:ext uri="{FF2B5EF4-FFF2-40B4-BE49-F238E27FC236}">
                <a16:creationId xmlns:a16="http://schemas.microsoft.com/office/drawing/2014/main" id="{C5372104-5A12-4FC1-9B7E-BA78D36DB306}"/>
              </a:ext>
            </a:extLst>
          </p:cNvPr>
          <p:cNvSpPr txBox="1"/>
          <p:nvPr/>
        </p:nvSpPr>
        <p:spPr>
          <a:xfrm>
            <a:off x="7187097" y="829733"/>
            <a:ext cx="4605866" cy="443198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50000"/>
              </a:lnSpc>
            </a:pPr>
            <a:r>
              <a:rPr lang="en-US" altLang="zh-C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. S1 Analysis of </a:t>
            </a:r>
            <a:r>
              <a:rPr lang="en-US" altLang="zh-CN" sz="16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ircRNA</a:t>
            </a:r>
            <a:r>
              <a:rPr lang="en-US" altLang="zh-C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rofiles in different mineralization osteoblasts. </a:t>
            </a:r>
          </a:p>
          <a:p>
            <a:pPr>
              <a:lnSpc>
                <a:spcPct val="150000"/>
              </a:lnSpc>
            </a:pPr>
            <a:r>
              <a:rPr lang="en-US" altLang="zh-C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-C</a:t>
            </a:r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Volcano plot depicting the expression of </a:t>
            </a:r>
            <a:r>
              <a:rPr lang="en-US" altLang="zh-CN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ircRNAs</a:t>
            </a:r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 osteoblasts at different mineralization stages. The red dots and green dots represent upregulated and downregulated </a:t>
            </a:r>
            <a:r>
              <a:rPr lang="en-US" altLang="zh-CN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ircRNAs</a:t>
            </a:r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with statistical significance, respectively. </a:t>
            </a:r>
            <a:r>
              <a:rPr lang="en-US" altLang="zh-C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US" altLang="zh-C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 </a:t>
            </a:r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Venn diagram showing the </a:t>
            </a:r>
            <a:r>
              <a:rPr lang="en-US" altLang="zh-CN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ircRNA</a:t>
            </a:r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expression continuously increasing or decreasing. </a:t>
            </a:r>
            <a:r>
              <a:rPr lang="en-US" altLang="zh-C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</a:t>
            </a:r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KEGG pathway analysis of differentially expressed </a:t>
            </a:r>
            <a:r>
              <a:rPr lang="en-US" altLang="zh-CN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ircRNAs</a:t>
            </a:r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endParaRPr lang="zh-CN" altLang="zh-CN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371316503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>
            <a:extLst>
              <a:ext uri="{FF2B5EF4-FFF2-40B4-BE49-F238E27FC236}">
                <a16:creationId xmlns:a16="http://schemas.microsoft.com/office/drawing/2014/main" id="{69298D37-AC30-4CF0-BF82-188CFF5FB93C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63980" y="0"/>
            <a:ext cx="8092784" cy="4680000"/>
          </a:xfrm>
          <a:prstGeom prst="rect">
            <a:avLst/>
          </a:prstGeom>
        </p:spPr>
      </p:pic>
      <p:sp>
        <p:nvSpPr>
          <p:cNvPr id="7" name="文本框 6">
            <a:extLst>
              <a:ext uri="{FF2B5EF4-FFF2-40B4-BE49-F238E27FC236}">
                <a16:creationId xmlns:a16="http://schemas.microsoft.com/office/drawing/2014/main" id="{9411928C-6B82-4C5C-BB8E-0CC9D54EDABA}"/>
              </a:ext>
            </a:extLst>
          </p:cNvPr>
          <p:cNvSpPr txBox="1"/>
          <p:nvPr/>
        </p:nvSpPr>
        <p:spPr>
          <a:xfrm>
            <a:off x="1064683" y="4536067"/>
            <a:ext cx="10062633" cy="221599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50000"/>
              </a:lnSpc>
            </a:pPr>
            <a:r>
              <a:rPr lang="en-US" altLang="zh-CN" sz="1600" dirty="0"/>
              <a:t> </a:t>
            </a:r>
            <a:endParaRPr lang="zh-CN" altLang="zh-CN" sz="1600" dirty="0"/>
          </a:p>
          <a:p>
            <a:pPr>
              <a:lnSpc>
                <a:spcPct val="150000"/>
              </a:lnSpc>
            </a:pPr>
            <a:r>
              <a:rPr lang="en-US" altLang="zh-C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. S2 Expression profiles of mRNAs in osteoblasts at different mineralization stages.</a:t>
            </a:r>
          </a:p>
          <a:p>
            <a:pPr>
              <a:lnSpc>
                <a:spcPct val="150000"/>
              </a:lnSpc>
            </a:pPr>
            <a:r>
              <a:rPr lang="en-US" altLang="zh-C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-C</a:t>
            </a:r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Volcano plot depicting the expression of mRNAs in osteoblast at different mineralization stages. The red dots and green dots represent upregulated and downregulated mRNAs with statistical significance, respectively. </a:t>
            </a:r>
            <a:r>
              <a:rPr lang="en-US" altLang="zh-C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US" altLang="zh-C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 </a:t>
            </a:r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Venn diagram showing mRNA expression continuously increasing or decreasing.</a:t>
            </a:r>
            <a:endParaRPr lang="zh-CN" altLang="zh-CN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141973610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>
            <a:extLst>
              <a:ext uri="{FF2B5EF4-FFF2-40B4-BE49-F238E27FC236}">
                <a16:creationId xmlns:a16="http://schemas.microsoft.com/office/drawing/2014/main" id="{123563E1-D148-4399-90E4-9FCD1EFBF947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41416" y="549000"/>
            <a:ext cx="9838781" cy="2880000"/>
          </a:xfrm>
          <a:prstGeom prst="rect">
            <a:avLst/>
          </a:prstGeom>
        </p:spPr>
      </p:pic>
      <p:sp>
        <p:nvSpPr>
          <p:cNvPr id="6" name="文本框 5">
            <a:extLst>
              <a:ext uri="{FF2B5EF4-FFF2-40B4-BE49-F238E27FC236}">
                <a16:creationId xmlns:a16="http://schemas.microsoft.com/office/drawing/2014/main" id="{2A8BAB57-C5AC-4E3C-ABBC-82C6253D5FF5}"/>
              </a:ext>
            </a:extLst>
          </p:cNvPr>
          <p:cNvSpPr txBox="1"/>
          <p:nvPr/>
        </p:nvSpPr>
        <p:spPr>
          <a:xfrm>
            <a:off x="1475023" y="3886201"/>
            <a:ext cx="9571566" cy="221599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50000"/>
              </a:lnSpc>
            </a:pPr>
            <a:r>
              <a:rPr lang="en-US" altLang="zh-C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. S3 Circ8500 inhibits the progression of osteoblasts. </a:t>
            </a:r>
          </a:p>
          <a:p>
            <a:pPr>
              <a:lnSpc>
                <a:spcPct val="150000"/>
              </a:lnSpc>
            </a:pPr>
            <a:r>
              <a:rPr lang="en-US" altLang="zh-C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.</a:t>
            </a:r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Relative expression levels of circ8500 in </a:t>
            </a:r>
            <a:r>
              <a:rPr lang="en-US" altLang="zh-CN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FOB</a:t>
            </a:r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1.19 cells were detected after transfecting with circ-NC, circ8500, </a:t>
            </a:r>
            <a:r>
              <a:rPr lang="en-US" altLang="zh-CN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h</a:t>
            </a:r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NC, or </a:t>
            </a:r>
            <a:r>
              <a:rPr lang="en-US" altLang="zh-CN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h</a:t>
            </a:r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circ. </a:t>
            </a:r>
            <a:r>
              <a:rPr lang="en-US" altLang="zh-C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.</a:t>
            </a:r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Relative mRNA expression levels of DLG1 in </a:t>
            </a:r>
            <a:r>
              <a:rPr lang="en-US" altLang="zh-CN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FOB</a:t>
            </a:r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1.19 cells were assessed after transfection with the indicated constructs. </a:t>
            </a:r>
            <a:r>
              <a:rPr lang="en-US" altLang="zh-C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.</a:t>
            </a:r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CK-8 assay showing the effect of circ8500 on the progression of osteoblasts. Data are represented as the mean value ± SD (</a:t>
            </a:r>
            <a:r>
              <a:rPr lang="en-US" altLang="zh-CN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n.s</a:t>
            </a:r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, not significant, **p &lt; 0.01, ***p &lt; 0.001).</a:t>
            </a:r>
            <a:endParaRPr lang="zh-CN" altLang="zh-CN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353948474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>
            <a:extLst>
              <a:ext uri="{FF2B5EF4-FFF2-40B4-BE49-F238E27FC236}">
                <a16:creationId xmlns:a16="http://schemas.microsoft.com/office/drawing/2014/main" id="{9C856215-28A9-4E60-817E-3324DB5EF381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48893" y="128777"/>
            <a:ext cx="8598731" cy="4320000"/>
          </a:xfrm>
          <a:prstGeom prst="rect">
            <a:avLst/>
          </a:prstGeom>
        </p:spPr>
      </p:pic>
      <p:sp>
        <p:nvSpPr>
          <p:cNvPr id="6" name="文本框 5">
            <a:extLst>
              <a:ext uri="{FF2B5EF4-FFF2-40B4-BE49-F238E27FC236}">
                <a16:creationId xmlns:a16="http://schemas.microsoft.com/office/drawing/2014/main" id="{6780833A-FEED-43B2-8E7D-467BE158F1C1}"/>
              </a:ext>
            </a:extLst>
          </p:cNvPr>
          <p:cNvSpPr txBox="1"/>
          <p:nvPr/>
        </p:nvSpPr>
        <p:spPr>
          <a:xfrm>
            <a:off x="262467" y="4553452"/>
            <a:ext cx="11641666" cy="258532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50000"/>
              </a:lnSpc>
            </a:pPr>
            <a:r>
              <a:rPr lang="en-US" altLang="zh-C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. S4 PADI4 promotes osteoblast mineralization.</a:t>
            </a:r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ADI4 overexpression constructs were transfected into </a:t>
            </a:r>
            <a:r>
              <a:rPr lang="en-US" altLang="zh-CN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FOB</a:t>
            </a:r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1.19 cells by lentivirus. </a:t>
            </a:r>
            <a:r>
              <a:rPr lang="en-US" altLang="zh-CN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FOB</a:t>
            </a:r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1.19 cells transfected with blank vectors were used as controls. In knockdown experiments, </a:t>
            </a:r>
            <a:r>
              <a:rPr lang="en-US" altLang="zh-CN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FOB</a:t>
            </a:r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1.19 cells were treated with Cl-amidine (50 </a:t>
            </a:r>
            <a:r>
              <a:rPr lang="en-US" altLang="zh-CN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μM</a:t>
            </a:r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, and the control </a:t>
            </a:r>
            <a:r>
              <a:rPr lang="en-US" altLang="zh-CN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FOB</a:t>
            </a:r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1.19 cells were treated with DMSO. </a:t>
            </a:r>
            <a:r>
              <a:rPr lang="en-US" altLang="zh-C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</a:t>
            </a:r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he effect of PADI4 on alkaline phosphatase activity in </a:t>
            </a:r>
            <a:r>
              <a:rPr lang="en-US" altLang="zh-CN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FOB</a:t>
            </a:r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1.19 cells at different mineralization stages. </a:t>
            </a:r>
            <a:r>
              <a:rPr lang="en-US" altLang="zh-C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)</a:t>
            </a:r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he effect of PADI4 on OCN during osteoblast mineralization. </a:t>
            </a:r>
            <a:r>
              <a:rPr lang="en-US" altLang="zh-C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C)</a:t>
            </a:r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Von </a:t>
            </a:r>
            <a:r>
              <a:rPr lang="en-US" altLang="zh-CN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ossa</a:t>
            </a:r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taining showing the mineralization of hFOB1.19 extracellular matrix with overexpression or inhibition of PADI4. Error bars (A, B) represent </a:t>
            </a:r>
            <a:r>
              <a:rPr lang="en-US" altLang="zh-CN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.d.</a:t>
            </a:r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n=3). </a:t>
            </a:r>
            <a:endParaRPr lang="zh-CN" altLang="zh-CN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418464616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1</TotalTime>
  <Words>354</Words>
  <Application>Microsoft Office PowerPoint</Application>
  <PresentationFormat>宽屏</PresentationFormat>
  <Paragraphs>8</Paragraphs>
  <Slides>4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4</vt:i4>
      </vt:variant>
    </vt:vector>
  </HeadingPairs>
  <TitlesOfParts>
    <vt:vector size="9" baseType="lpstr">
      <vt:lpstr>等线</vt:lpstr>
      <vt:lpstr>等线 Light</vt:lpstr>
      <vt:lpstr>Arial</vt:lpstr>
      <vt:lpstr>Times New Roman</vt:lpstr>
      <vt:lpstr>Office 主题​​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Wang Lianqing</dc:creator>
  <cp:lastModifiedBy>Wang Lianqing</cp:lastModifiedBy>
  <cp:revision>2</cp:revision>
  <dcterms:created xsi:type="dcterms:W3CDTF">2020-04-24T01:20:52Z</dcterms:created>
  <dcterms:modified xsi:type="dcterms:W3CDTF">2020-04-24T01:32:52Z</dcterms:modified>
</cp:coreProperties>
</file>